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884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4A149-89D9-5A06-BA83-CAAF7F721A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DE4BF8-5B3F-F7DB-C290-6C4325916A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491F3C-FAF9-8143-DAC4-EB2F180E9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CE24D7-7185-C4E1-4E34-0CAC5D9EF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C54836-DA5A-C797-CDCA-E2A788BF04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12676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ABAB19-6E0B-4449-67B3-AF99BEAB2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D2CD10-FDAF-90BB-57EC-1DE5EB31B7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A03627-284A-9681-4808-2E5DB51D0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53D8C6-D915-9BB9-7DE0-198616949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1A0100-4C9E-1EC5-6590-0E1F1EE35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20448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7D2B5F-D087-821C-F678-12FDF6E883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D2F7A2-A490-C550-65EE-06FB178B7D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EDD075-BBF8-4376-5A59-EF880F645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C6DF3F-68CA-D84F-5E11-284F2EAD1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EC4B5D-03C5-2BB6-1501-81C6BBDEB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3750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AC3559-B8D1-9F42-ABE6-F040505816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4AF0D4-E6B7-3633-BFA7-0C740F8143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9C4BA9-799B-3718-AACB-0E46937FB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1CCB80-43CD-43FF-9972-76C977355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4B43B2-E3A5-4C24-5EE6-4D7C6EE7F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5398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62E72E-C1D7-0F8E-6C26-720D1F0B2F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11C938-9C77-F611-BED4-7A49FEB1A0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6955CA-60E9-09E6-F8E3-68594AED5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5DE7F-A976-F99C-AD07-F7720E191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3EFE8B-C321-BC6D-695B-F1754BA6F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9978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8226B9-18ED-0579-4DD6-FE0C487218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7BF80C-81B0-C8C1-061C-B55BCD198F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9AC869-D01F-7AC3-D769-BB452B3312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2EFE38-9CFD-0DEB-F642-37A1568D6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597858-AC93-31A4-D761-F875A929A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E73B16-AE30-2E4E-5AF7-BE787FFAB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89265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D3B47-346F-86AB-0DCE-A1D08884A7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D44493-6AAC-7499-CFEE-A6A3DF375C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7EE1B0-1E6C-F8DB-3CC6-60B4A35DB1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68AB1F-E06E-8A41-ECB1-98B06E68C7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192C77-F6C4-2662-DCD1-22C1279121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E9FA14-6C2D-32D0-6D0E-959DEAD1D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207BE5-47BD-2FF7-6ABA-7175522377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8698806-C481-C26B-7A29-2B679F339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65661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8FB856-73AD-DE43-16E3-1C55D70AE5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07A063-98F8-F432-27E4-2F30A07F6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FF0D5B-478D-AE58-BE94-BDC4D2B8D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FAFDF2-C1E3-EA59-48DB-CBB7294D3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3656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4569C5-616D-E78A-D3A7-495352EA8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884F9D-3602-1579-243C-C54A1AB20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FCA588-89AA-C97F-66D4-237D332E1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35157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397BE-A6B5-7D6E-7D9D-2C3BC8DF29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38BBF5-B65A-3B97-8F3E-70AACF4F6C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120C7F-93D5-A2DB-991D-62B4A52021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410254-435A-CCF7-2949-673E6B86B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EE1040-3FFA-841B-E860-7AC6E16C5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1CEAA3-0A9A-A680-2C4B-30366A46E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57313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A7DE8C-0790-A53E-AC3B-D62ABFABF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3E06B4D-4498-EC2D-283C-8897003587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E90831-6F2D-ED3C-316E-17A16DFF41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A1D313-5FFC-25CC-8F5A-47A0759DA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EC7A21-CDFC-2921-81C2-CC21312AF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175B48-726F-CB9C-99BC-597DD295C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15198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6388C7F-E774-C1C0-82A0-548C5C3C6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C05601-2C42-0969-6D88-B03AA6CC7F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D5EB1F-CACF-3DD3-404A-B7D1E4C7B3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141929-A49E-4F86-BAFC-F5093AD157E2}" type="datetimeFigureOut">
              <a:rPr lang="en-AU" smtClean="0"/>
              <a:t>13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F091CE-FD60-6393-1BD8-1D5570D6D9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10D6A6-AE36-9097-CFAE-4FC7DCFDC7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95CC2C-DC11-41CF-AB43-0B98977237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6223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AD58BFA-ED29-A3EA-9CEE-B0676D8516F4}"/>
              </a:ext>
            </a:extLst>
          </p:cNvPr>
          <p:cNvSpPr/>
          <p:nvPr/>
        </p:nvSpPr>
        <p:spPr>
          <a:xfrm>
            <a:off x="4887310" y="133684"/>
            <a:ext cx="2417380" cy="9144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AU" dirty="0"/>
              <a:t>Contacted about the study </a:t>
            </a:r>
          </a:p>
          <a:p>
            <a:pPr algn="ctr"/>
            <a:r>
              <a:rPr lang="en-AU" dirty="0"/>
              <a:t>n=170 (79% men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31DE5BC-2D20-974C-968B-1788B8A74E5D}"/>
              </a:ext>
            </a:extLst>
          </p:cNvPr>
          <p:cNvSpPr/>
          <p:nvPr/>
        </p:nvSpPr>
        <p:spPr>
          <a:xfrm>
            <a:off x="6815959" y="1279097"/>
            <a:ext cx="3505200" cy="9144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AU" dirty="0"/>
              <a:t>Did not fulfill the inclusion criteria n=48 (66% men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67B9DEB-7A69-BD79-B197-A359D98D0FE0}"/>
              </a:ext>
            </a:extLst>
          </p:cNvPr>
          <p:cNvSpPr/>
          <p:nvPr/>
        </p:nvSpPr>
        <p:spPr>
          <a:xfrm>
            <a:off x="3116317" y="2157251"/>
            <a:ext cx="2417380" cy="9144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AU" dirty="0"/>
              <a:t>Declined </a:t>
            </a:r>
          </a:p>
          <a:p>
            <a:pPr algn="ctr"/>
            <a:r>
              <a:rPr lang="en-AU" dirty="0"/>
              <a:t>n=33 (76% men)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4F776129-CA7C-E11E-4CA9-04579F5D0891}"/>
              </a:ext>
            </a:extLst>
          </p:cNvPr>
          <p:cNvCxnSpPr>
            <a:cxnSpLocks/>
          </p:cNvCxnSpPr>
          <p:nvPr/>
        </p:nvCxnSpPr>
        <p:spPr>
          <a:xfrm>
            <a:off x="6096000" y="1145636"/>
            <a:ext cx="0" cy="22833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134E6F41-62DF-1E99-DB5F-C1A8EFE7D72D}"/>
              </a:ext>
            </a:extLst>
          </p:cNvPr>
          <p:cNvSpPr/>
          <p:nvPr/>
        </p:nvSpPr>
        <p:spPr>
          <a:xfrm>
            <a:off x="4892568" y="3554792"/>
            <a:ext cx="2417380" cy="9144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AU" dirty="0"/>
              <a:t>Included in the study n=89 (88% men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D928EF6-E8CF-8F1B-7DC8-A6334E9DC5D1}"/>
              </a:ext>
            </a:extLst>
          </p:cNvPr>
          <p:cNvSpPr/>
          <p:nvPr/>
        </p:nvSpPr>
        <p:spPr>
          <a:xfrm>
            <a:off x="4892563" y="5809916"/>
            <a:ext cx="2529103" cy="9144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AU" dirty="0"/>
              <a:t>Complete study cohort n=87 (87% men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0D2986D-696D-D3AA-6410-58342A59FEF4}"/>
              </a:ext>
            </a:extLst>
          </p:cNvPr>
          <p:cNvSpPr/>
          <p:nvPr/>
        </p:nvSpPr>
        <p:spPr>
          <a:xfrm>
            <a:off x="6810700" y="4674133"/>
            <a:ext cx="3109909" cy="914400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AU" dirty="0"/>
              <a:t>Excluded, did not complete the test session</a:t>
            </a:r>
          </a:p>
          <a:p>
            <a:pPr algn="ctr"/>
            <a:r>
              <a:rPr lang="en-AU" dirty="0"/>
              <a:t>n=2, (100% men)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A777BEE-A9F2-2683-B359-BF644CC6982A}"/>
              </a:ext>
            </a:extLst>
          </p:cNvPr>
          <p:cNvCxnSpPr>
            <a:cxnSpLocks/>
          </p:cNvCxnSpPr>
          <p:nvPr/>
        </p:nvCxnSpPr>
        <p:spPr>
          <a:xfrm>
            <a:off x="6096000" y="4572005"/>
            <a:ext cx="0" cy="114035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4DECD22-CD52-C261-10DB-57D8AA3061E5}"/>
              </a:ext>
            </a:extLst>
          </p:cNvPr>
          <p:cNvCxnSpPr>
            <a:cxnSpLocks/>
          </p:cNvCxnSpPr>
          <p:nvPr/>
        </p:nvCxnSpPr>
        <p:spPr>
          <a:xfrm>
            <a:off x="6146104" y="1730034"/>
            <a:ext cx="61168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699EF8D9-C0A0-FC9B-E2DE-AB5E8FA331D3}"/>
              </a:ext>
            </a:extLst>
          </p:cNvPr>
          <p:cNvCxnSpPr>
            <a:cxnSpLocks/>
          </p:cNvCxnSpPr>
          <p:nvPr/>
        </p:nvCxnSpPr>
        <p:spPr>
          <a:xfrm>
            <a:off x="6133578" y="5145464"/>
            <a:ext cx="61168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F24A6BC3-28EC-D0C5-A477-47F81D2BE9D5}"/>
              </a:ext>
            </a:extLst>
          </p:cNvPr>
          <p:cNvCxnSpPr>
            <a:cxnSpLocks/>
          </p:cNvCxnSpPr>
          <p:nvPr/>
        </p:nvCxnSpPr>
        <p:spPr>
          <a:xfrm flipH="1">
            <a:off x="5580345" y="2577628"/>
            <a:ext cx="44676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16867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University of Canber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anda.Lonn</dc:creator>
  <cp:lastModifiedBy>Amanda.Lonn</cp:lastModifiedBy>
  <cp:revision>1</cp:revision>
  <dcterms:created xsi:type="dcterms:W3CDTF">2025-06-13T06:57:41Z</dcterms:created>
  <dcterms:modified xsi:type="dcterms:W3CDTF">2025-06-13T06:58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f6fef03-d487-4433-8e43-6b81c0a1b7be_Enabled">
    <vt:lpwstr>true</vt:lpwstr>
  </property>
  <property fmtid="{D5CDD505-2E9C-101B-9397-08002B2CF9AE}" pid="3" name="MSIP_Label_bf6fef03-d487-4433-8e43-6b81c0a1b7be_SetDate">
    <vt:lpwstr>2025-06-13T06:58:10Z</vt:lpwstr>
  </property>
  <property fmtid="{D5CDD505-2E9C-101B-9397-08002B2CF9AE}" pid="4" name="MSIP_Label_bf6fef03-d487-4433-8e43-6b81c0a1b7be_Method">
    <vt:lpwstr>Standard</vt:lpwstr>
  </property>
  <property fmtid="{D5CDD505-2E9C-101B-9397-08002B2CF9AE}" pid="5" name="MSIP_Label_bf6fef03-d487-4433-8e43-6b81c0a1b7be_Name">
    <vt:lpwstr>Unclassified</vt:lpwstr>
  </property>
  <property fmtid="{D5CDD505-2E9C-101B-9397-08002B2CF9AE}" pid="6" name="MSIP_Label_bf6fef03-d487-4433-8e43-6b81c0a1b7be_SiteId">
    <vt:lpwstr>1daf5147-a543-4707-a2fb-2acf0b2a3936</vt:lpwstr>
  </property>
  <property fmtid="{D5CDD505-2E9C-101B-9397-08002B2CF9AE}" pid="7" name="MSIP_Label_bf6fef03-d487-4433-8e43-6b81c0a1b7be_ActionId">
    <vt:lpwstr>d0341db3-8547-49c2-8ca0-e1e55be0cf8a</vt:lpwstr>
  </property>
  <property fmtid="{D5CDD505-2E9C-101B-9397-08002B2CF9AE}" pid="8" name="MSIP_Label_bf6fef03-d487-4433-8e43-6b81c0a1b7be_ContentBits">
    <vt:lpwstr>0</vt:lpwstr>
  </property>
  <property fmtid="{D5CDD505-2E9C-101B-9397-08002B2CF9AE}" pid="9" name="MSIP_Label_bf6fef03-d487-4433-8e43-6b81c0a1b7be_Tag">
    <vt:lpwstr>10, 3, 0, 1</vt:lpwstr>
  </property>
</Properties>
</file>